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71" r:id="rId2"/>
    <p:sldId id="270" r:id="rId3"/>
    <p:sldId id="269" r:id="rId4"/>
    <p:sldId id="266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3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elma F. Madzima" initials="TFM" lastIdx="1" clrIdx="0">
    <p:extLst>
      <p:ext uri="{19B8F6BF-5375-455C-9EA6-DF929625EA0E}">
        <p15:presenceInfo xmlns:p15="http://schemas.microsoft.com/office/powerpoint/2012/main" userId="S::madzima@uw.edu::b689fd5f-dba7-4ae4-b0c5-aabcfc4e49a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F0D9"/>
    <a:srgbClr val="7EB0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569" autoAdjust="0"/>
    <p:restoredTop sz="86406" autoAdjust="0"/>
  </p:normalViewPr>
  <p:slideViewPr>
    <p:cSldViewPr snapToGrid="0" snapToObjects="1" showGuides="1">
      <p:cViewPr varScale="1">
        <p:scale>
          <a:sx n="74" d="100"/>
          <a:sy n="74" d="100"/>
        </p:scale>
        <p:origin x="3034" y="62"/>
      </p:cViewPr>
      <p:guideLst>
        <p:guide orient="horz" pos="2880"/>
        <p:guide pos="213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CA7DD-038E-1149-9B59-69222E7570CE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CFD7D9-A83B-4949-9AE7-3466BA0583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2226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CFD7D9-A83B-4949-9AE7-3466BA0583C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9055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CFD7D9-A83B-4949-9AE7-3466BA0583C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58176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CFD7D9-A83B-4949-9AE7-3466BA0583C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97187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CFD7D9-A83B-4949-9AE7-3466BA0583C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5952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654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70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785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985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693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48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715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315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89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494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082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5F43C-956F-5148-9EA6-DBEF68E223F1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CCB79-9B41-7744-B632-BD3527AC49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523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D504C4C-415B-6E4A-B5E9-0128842E4F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703384"/>
            <a:ext cx="6858000" cy="4572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26233DA7-C394-6445-880C-B72C1C0E5B80}"/>
              </a:ext>
            </a:extLst>
          </p:cNvPr>
          <p:cNvSpPr/>
          <p:nvPr/>
        </p:nvSpPr>
        <p:spPr>
          <a:xfrm>
            <a:off x="1002726" y="6243976"/>
            <a:ext cx="485254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shold normalization for uniquely mapping reads.</a:t>
            </a:r>
          </a:p>
        </p:txBody>
      </p:sp>
    </p:spTree>
    <p:extLst>
      <p:ext uri="{BB962C8B-B14F-4D97-AF65-F5344CB8AC3E}">
        <p14:creationId xmlns:p14="http://schemas.microsoft.com/office/powerpoint/2010/main" val="2079484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F2FD47C-96C9-854D-B637-A72FDA46B2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896" y="1384102"/>
            <a:ext cx="3200400" cy="278091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8C7A12A-0A38-604F-97A0-897DBD86FD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18703" y="1384102"/>
            <a:ext cx="3200400" cy="278091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F99980E-8D62-F641-9F7D-9C70A23DFCA7}"/>
              </a:ext>
            </a:extLst>
          </p:cNvPr>
          <p:cNvSpPr/>
          <p:nvPr/>
        </p:nvSpPr>
        <p:spPr>
          <a:xfrm>
            <a:off x="463228" y="5228001"/>
            <a:ext cx="58553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-analysis of differentially expressed genes (DEGs) after 8h ABA treatment.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42A7E33-1646-F34C-8BE1-BC80368EED70}"/>
              </a:ext>
            </a:extLst>
          </p:cNvPr>
          <p:cNvSpPr txBox="1"/>
          <p:nvPr/>
        </p:nvSpPr>
        <p:spPr>
          <a:xfrm>
            <a:off x="138896" y="609600"/>
            <a:ext cx="534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8B1EA13-4AAA-7F48-8B28-3A20980CD681}"/>
              </a:ext>
            </a:extLst>
          </p:cNvPr>
          <p:cNvSpPr txBox="1"/>
          <p:nvPr/>
        </p:nvSpPr>
        <p:spPr>
          <a:xfrm>
            <a:off x="3390900" y="616982"/>
            <a:ext cx="534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6509781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D137FFE-19BE-B04A-99DC-BA728B145799}"/>
              </a:ext>
            </a:extLst>
          </p:cNvPr>
          <p:cNvGrpSpPr/>
          <p:nvPr/>
        </p:nvGrpSpPr>
        <p:grpSpPr>
          <a:xfrm>
            <a:off x="228600" y="279400"/>
            <a:ext cx="6400800" cy="5892800"/>
            <a:chOff x="381000" y="1569357"/>
            <a:chExt cx="6400800" cy="58928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68D793D-E9CD-0C4F-BAF3-AAA487CC1BB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1000" y="1569357"/>
              <a:ext cx="3200400" cy="32004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A39F712-D976-0242-9740-CF051EAF91F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81400" y="1609269"/>
              <a:ext cx="3200400" cy="32004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AC55940-7430-044A-AA8D-F7CFD36A93C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9900" y="4261757"/>
              <a:ext cx="3200400" cy="32004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4DF2F58-B1BE-DD47-806E-BCE93110290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36950" y="4261757"/>
              <a:ext cx="3200400" cy="3200400"/>
            </a:xfrm>
            <a:prstGeom prst="rect">
              <a:avLst/>
            </a:prstGeom>
          </p:spPr>
        </p:pic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57AC4535-24C5-A547-AA14-637C5BE94DE9}"/>
              </a:ext>
            </a:extLst>
          </p:cNvPr>
          <p:cNvSpPr/>
          <p:nvPr/>
        </p:nvSpPr>
        <p:spPr>
          <a:xfrm>
            <a:off x="628650" y="6431376"/>
            <a:ext cx="5377058" cy="2877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200" b="1" dirty="0">
                <a:solidFill>
                  <a:srgbClr val="141414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differentially expressed genes (DEGs) in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8h/1h compariso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551EFFA-E964-4E42-9DDD-E67D6ED88CAE}"/>
              </a:ext>
            </a:extLst>
          </p:cNvPr>
          <p:cNvSpPr txBox="1"/>
          <p:nvPr/>
        </p:nvSpPr>
        <p:spPr>
          <a:xfrm>
            <a:off x="412750" y="319312"/>
            <a:ext cx="534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748AA17-768D-B440-BCA8-F55DB1707243}"/>
              </a:ext>
            </a:extLst>
          </p:cNvPr>
          <p:cNvSpPr txBox="1"/>
          <p:nvPr/>
        </p:nvSpPr>
        <p:spPr>
          <a:xfrm>
            <a:off x="3437745" y="319312"/>
            <a:ext cx="534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7BA384B-71D4-6E4B-B558-7E0890E4D61D}"/>
              </a:ext>
            </a:extLst>
          </p:cNvPr>
          <p:cNvSpPr txBox="1"/>
          <p:nvPr/>
        </p:nvSpPr>
        <p:spPr>
          <a:xfrm>
            <a:off x="412750" y="3156466"/>
            <a:ext cx="534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6BBB262-9BB0-A141-98D0-4C967FD9823E}"/>
              </a:ext>
            </a:extLst>
          </p:cNvPr>
          <p:cNvSpPr txBox="1"/>
          <p:nvPr/>
        </p:nvSpPr>
        <p:spPr>
          <a:xfrm>
            <a:off x="3384550" y="3150380"/>
            <a:ext cx="534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25002419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7809D2A-C0DD-774A-A387-853D7550693B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361647"/>
            <a:ext cx="5943600" cy="157226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24287" y="3687365"/>
            <a:ext cx="5926347" cy="6719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 smtClean="0">
                <a:solidFill>
                  <a:srgbClr val="141414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4.  Additional </a:t>
            </a:r>
            <a:r>
              <a:rPr lang="en-US" dirty="0" smtClean="0"/>
              <a:t>physiological </a:t>
            </a:r>
            <a:r>
              <a:rPr lang="en-US" dirty="0"/>
              <a:t>observations from drought stress experiment.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8146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19</TotalTime>
  <Words>77</Words>
  <Application>Microsoft Office PowerPoint</Application>
  <PresentationFormat>Letter Paper (8.5x11 in)</PresentationFormat>
  <Paragraphs>15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elma F. Madzima</dc:creator>
  <cp:lastModifiedBy>Karen McGinnis</cp:lastModifiedBy>
  <cp:revision>75</cp:revision>
  <dcterms:created xsi:type="dcterms:W3CDTF">2020-12-22T20:19:25Z</dcterms:created>
  <dcterms:modified xsi:type="dcterms:W3CDTF">2021-04-12T18:43:18Z</dcterms:modified>
</cp:coreProperties>
</file>